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93"/>
    <p:restoredTop sz="94851" autoAdjust="0"/>
  </p:normalViewPr>
  <p:slideViewPr>
    <p:cSldViewPr>
      <p:cViewPr>
        <p:scale>
          <a:sx n="90" d="100"/>
          <a:sy n="90" d="100"/>
        </p:scale>
        <p:origin x="-3036" y="3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873EA3-AC53-4C4C-A7EE-7B3CD0096699}" type="datetimeFigureOut">
              <a:t>4/19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EDF2CD-FDA2-EC45-81FB-F704CD942F2C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447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EDF2CD-FDA2-EC45-81FB-F704CD942F2C}" type="slidenum"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0540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828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625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611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716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69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633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8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926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826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547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9BB79-3F39-4E6A-9480-42D9C0773864}" type="datetimeFigureOut">
              <a:rPr lang="en-US" smtClean="0"/>
              <a:t>4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16724-DDF0-4B43-89EB-78CF982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448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fld id="{3819BB79-3F39-4E6A-9480-42D9C0773864}" type="datetimeFigureOut">
              <a:rPr lang="en-US" smtClean="0"/>
              <a:pPr/>
              <a:t>4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fld id="{6D416724-DDF0-4B43-89EB-78CF982624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760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Arial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Arial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Arial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Arial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Arial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85980" y="6012160"/>
            <a:ext cx="56964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457200">
              <a:defRPr/>
            </a:pPr>
            <a:r>
              <a:rPr lang="en-US" sz="1000" b="1" dirty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Figure </a:t>
            </a:r>
            <a:r>
              <a:rPr lang="en-US" sz="1000" b="1" dirty="0" smtClean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S2. </a:t>
            </a:r>
            <a:r>
              <a:rPr lang="en-US" sz="1000" b="1" dirty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Box plot representation of exon (a) and intron (b) RPKMs under different stress conditions. </a:t>
            </a:r>
            <a:endParaRPr lang="en-US" sz="1000" b="1" dirty="0" smtClean="0">
              <a:solidFill>
                <a:srgbClr val="00000A"/>
              </a:solidFill>
              <a:latin typeface="Arial"/>
              <a:ea typeface="Droid Sans Fallback"/>
              <a:cs typeface="Arial"/>
            </a:endParaRPr>
          </a:p>
          <a:p>
            <a:pPr algn="just" defTabSz="457200">
              <a:defRPr/>
            </a:pPr>
            <a:r>
              <a:rPr lang="en-US" sz="1000" dirty="0" smtClean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The </a:t>
            </a:r>
            <a:r>
              <a:rPr lang="en-US" sz="1000" dirty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thick horizontal bars represent the median RPKM value, and the top and bottom extents of the boxes represent 25% and 75% of the distribution, respectively. The top and bottom whiskers represent the highest and lowest RPKM values, respectively. There is no bottom whisker in </a:t>
            </a:r>
            <a:r>
              <a:rPr lang="en-US" sz="1000" b="1" dirty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(a)</a:t>
            </a:r>
            <a:r>
              <a:rPr lang="en-US" sz="1000" dirty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 because the minimum value is 0 RPKM </a:t>
            </a:r>
            <a:r>
              <a:rPr lang="en-US" sz="1000" dirty="0" smtClean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for some </a:t>
            </a:r>
            <a:r>
              <a:rPr lang="en-US" sz="1000" dirty="0" err="1" smtClean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tRNA</a:t>
            </a:r>
            <a:r>
              <a:rPr lang="en-US" sz="1000" dirty="0" smtClean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 exons under </a:t>
            </a:r>
            <a:r>
              <a:rPr lang="en-US" sz="1000" dirty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every </a:t>
            </a:r>
            <a:r>
              <a:rPr lang="en-US" sz="1000" dirty="0" smtClean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condition.</a:t>
            </a:r>
            <a:endParaRPr lang="en-US" sz="1000" dirty="0">
              <a:solidFill>
                <a:srgbClr val="00000A"/>
              </a:solidFill>
              <a:latin typeface="Arial"/>
              <a:ea typeface="Droid Sans Fallback"/>
              <a:cs typeface="Arial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5980" y="827584"/>
            <a:ext cx="5696421" cy="46543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91436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Office PowerPoint</Application>
  <PresentationFormat>Letter Paper (8.5x11 in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oît</dc:creator>
  <cp:lastModifiedBy>Benoît</cp:lastModifiedBy>
  <cp:revision>8</cp:revision>
  <dcterms:created xsi:type="dcterms:W3CDTF">2015-11-30T20:05:19Z</dcterms:created>
  <dcterms:modified xsi:type="dcterms:W3CDTF">2016-04-19T16:08:29Z</dcterms:modified>
</cp:coreProperties>
</file>